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72" r:id="rId3"/>
    <p:sldId id="279" r:id="rId4"/>
    <p:sldId id="269" r:id="rId5"/>
    <p:sldId id="274" r:id="rId6"/>
    <p:sldId id="275" r:id="rId7"/>
    <p:sldId id="27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FEFEF"/>
    <a:srgbClr val="00709B"/>
    <a:srgbClr val="66A9C3"/>
    <a:srgbClr val="009999"/>
    <a:srgbClr val="660066"/>
    <a:srgbClr val="993366"/>
    <a:srgbClr val="EA6C16"/>
    <a:srgbClr val="0066CC"/>
    <a:srgbClr val="00CC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57" autoAdjust="0"/>
    <p:restoredTop sz="95948" autoAdjust="0"/>
  </p:normalViewPr>
  <p:slideViewPr>
    <p:cSldViewPr snapToGrid="0">
      <p:cViewPr varScale="1">
        <p:scale>
          <a:sx n="89" d="100"/>
          <a:sy n="89" d="100"/>
        </p:scale>
        <p:origin x="90" y="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C7CAA-2CA2-4320-8C94-D0DCB46BF3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C1B8EB-87A2-4846-BCD7-201AFF1C3D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CFA4E8-EB87-4FAE-B0B8-742008204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0E9877-3FBC-4D92-9548-CA8E6C956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9BA688-D0D9-4A3D-AEE8-98B637726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8212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B42DF7-7471-441D-957B-52EA73BBBF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259806-7226-4396-9046-1937DB7A2C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CBC2BB-EC41-4D02-B49B-6CCA2DD00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11660A-EB7C-4CCA-ACF5-6502E4F0C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085B66-C524-47C2-981E-E731281F7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3276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E117BB-12C1-4960-9845-8A080F8B8E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4C5B7D-FDF4-4E75-961C-C7FEB15C9F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4284AB-FA83-4562-87F1-B40D7D7D2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6E9A29-9209-434A-ABFF-AD42C2087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FC750F-8BE7-4556-980F-38A6AFD48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7987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5126D0-F6E6-47AD-B959-E6F66B4B0E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5CF28-4F05-4158-8F9C-9141CD7789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A75F1B-720D-47C6-886E-CBFD7C349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DC960F-15EA-4CEC-B722-A0E751CE0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F287A5-29B1-4807-9B58-687F1B97D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1265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34EFBB-9BDC-4E77-91DE-68B62854FE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CAB950-8ABE-4ECF-9533-F958F10D9B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1732A2-7415-418B-A98B-60522CC77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9B9EA5-1BCD-4095-A8F1-828040B54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56ED81-4E4B-4809-83C8-EAF99C2ED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0105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E98FCA-DBCC-4916-8C7B-D466FE74FD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6413F3-1CD4-4455-A413-40B24891D9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CC9722-F259-4077-92F4-620E8FB194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1F0697-C7DF-4EA1-8E63-049C3C49C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A3C585-3F5B-471B-A9D8-D7A557A69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2C2762-2D14-44CA-B71B-A2FFE37B7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9220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71EA6E-62A0-4AAD-980F-B6283BDA22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712C23-8A50-4004-89C9-45CF4D9D2A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0951E4-7115-4878-99A5-2D7BFC63A4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76B13F-FEB7-46AE-BCD2-6E525F40CB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31FBDB-0430-4B51-88D1-A7FA6D8087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1B2FDB-263C-4614-A3EB-B5C7A3DC1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C4C60C-51F9-4826-84AC-89F8ADBB8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4D8EB1-4508-4253-96D5-F23DA60B0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47010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3B9BEF-5D80-449E-967F-E471AC965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6EE9CB-D971-4D35-AA41-855F34B38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5F4250-71EE-479A-91E1-6F7CF3C17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DD457D-52B8-4339-A39F-9114C028E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519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1473CD4-E641-4F3E-BFAF-E49761FD5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48F9860-A6A7-4286-B4B9-739D19928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6B6782-EF87-4530-B7FE-E6D72C35C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44704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3508D-66FD-4272-AD4A-7A109F7F6A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7CE672-FFF4-4B5A-9620-D3F39E883B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BF5E99-4992-45C4-9CAF-327437BBE8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654539-DF3A-4EAD-9C38-6363CBA39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6A3D99-CE18-41D9-8068-9A91B8704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094F16-FA71-4ADB-B2F7-BC5896068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506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282C4-15B7-4C61-82ED-11C39D346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DFF7878-BF88-4C91-9884-A62BFCDE97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ADCF77-5052-4E1A-97CB-644F766486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CFDED1-AC28-4AC1-9E8E-DB68558C1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E6F4A7-F57E-48BC-95A7-FEEC37EC8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6F3C1E-585A-4857-847D-2F57CCB5B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5448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81C145A-E6C1-462B-AF22-FF3ABCC0ED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2FBA0A-E754-471B-8711-CD83B882AE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4D9759-F8FD-4241-ADD8-A6A46FA8BF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04BC25-BD83-4965-84DD-31A8DE27A946}" type="datetimeFigureOut">
              <a:rPr lang="en-AU" smtClean="0"/>
              <a:t>22/12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28D1DC-1F0A-4D9D-97C4-D7C27D3760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26602A-04AC-42DB-93D9-A4549A15E9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7B37A-B9F0-488D-BC7C-637CBD7230F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84278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60E4042-9BB1-44DD-B808-64106EA64064}"/>
              </a:ext>
            </a:extLst>
          </p:cNvPr>
          <p:cNvGrpSpPr/>
          <p:nvPr/>
        </p:nvGrpSpPr>
        <p:grpSpPr>
          <a:xfrm>
            <a:off x="0" y="-3632"/>
            <a:ext cx="7899727" cy="6737919"/>
            <a:chOff x="0" y="-3632"/>
            <a:chExt cx="7899727" cy="673791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B3A3C29-65DB-4ECE-AF42-9D143494B5C7}"/>
                </a:ext>
              </a:extLst>
            </p:cNvPr>
            <p:cNvSpPr txBox="1"/>
            <p:nvPr/>
          </p:nvSpPr>
          <p:spPr>
            <a:xfrm>
              <a:off x="0" y="-3632"/>
              <a:ext cx="78997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/>
                <a:t>Vincent et al - Supplementary Figure S1: PCA to validate a flour weight of 20 mg across 6 wheat cultivars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99356A07-680E-43F1-9FF3-6F81D758D2C4}"/>
                </a:ext>
              </a:extLst>
            </p:cNvPr>
            <p:cNvGrpSpPr/>
            <p:nvPr/>
          </p:nvGrpSpPr>
          <p:grpSpPr>
            <a:xfrm>
              <a:off x="94062" y="267391"/>
              <a:ext cx="6661740" cy="6466896"/>
              <a:chOff x="94062" y="267391"/>
              <a:chExt cx="6661740" cy="6466896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CB5FB41C-54BD-4D6B-8FE8-5BEA583D38C0}"/>
                  </a:ext>
                </a:extLst>
              </p:cNvPr>
              <p:cNvGrpSpPr/>
              <p:nvPr/>
            </p:nvGrpSpPr>
            <p:grpSpPr>
              <a:xfrm>
                <a:off x="233916" y="1470964"/>
                <a:ext cx="5413849" cy="5263323"/>
                <a:chOff x="287079" y="552894"/>
                <a:chExt cx="6124354" cy="6051013"/>
              </a:xfrm>
            </p:grpSpPr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FF3DE857-9B50-43B3-9D40-0E7CF77E596A}"/>
                    </a:ext>
                  </a:extLst>
                </p:cNvPr>
                <p:cNvSpPr/>
                <p:nvPr/>
              </p:nvSpPr>
              <p:spPr>
                <a:xfrm>
                  <a:off x="287079" y="552894"/>
                  <a:ext cx="6124354" cy="605101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/>
                </a:p>
              </p:txBody>
            </p:sp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6E9C6EC5-DF23-49ED-8F1D-696C6C13205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54669" t="6295" b="3433"/>
                <a:stretch/>
              </p:blipFill>
              <p:spPr>
                <a:xfrm>
                  <a:off x="433750" y="607084"/>
                  <a:ext cx="5977683" cy="5975557"/>
                </a:xfrm>
                <a:prstGeom prst="rect">
                  <a:avLst/>
                </a:prstGeom>
              </p:spPr>
            </p:pic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544C3716-ADA6-4639-BB5C-0262AD241BF7}"/>
                    </a:ext>
                  </a:extLst>
                </p:cNvPr>
                <p:cNvGrpSpPr/>
                <p:nvPr/>
              </p:nvGrpSpPr>
              <p:grpSpPr>
                <a:xfrm>
                  <a:off x="4130286" y="775545"/>
                  <a:ext cx="1997675" cy="1804570"/>
                  <a:chOff x="1998921" y="3127787"/>
                  <a:chExt cx="1997675" cy="1804570"/>
                </a:xfrm>
              </p:grpSpPr>
              <p:sp>
                <p:nvSpPr>
                  <p:cNvPr id="19" name="Rectangle 18">
                    <a:extLst>
                      <a:ext uri="{FF2B5EF4-FFF2-40B4-BE49-F238E27FC236}">
                        <a16:creationId xmlns:a16="http://schemas.microsoft.com/office/drawing/2014/main" id="{D706C575-3A42-4AD1-8CAC-6F8151C7181D}"/>
                      </a:ext>
                    </a:extLst>
                  </p:cNvPr>
                  <p:cNvSpPr/>
                  <p:nvPr/>
                </p:nvSpPr>
                <p:spPr>
                  <a:xfrm>
                    <a:off x="1998921" y="3152523"/>
                    <a:ext cx="1962153" cy="175432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AU"/>
                  </a:p>
                </p:txBody>
              </p: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A767FC9C-CADB-4B54-8B98-3CAB6E230944}"/>
                      </a:ext>
                    </a:extLst>
                  </p:cNvPr>
                  <p:cNvSpPr txBox="1"/>
                  <p:nvPr/>
                </p:nvSpPr>
                <p:spPr>
                  <a:xfrm>
                    <a:off x="2286000" y="3127787"/>
                    <a:ext cx="1710596" cy="180457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AU" sz="1600" dirty="0"/>
                      <a:t>SUNTOP</a:t>
                    </a:r>
                  </a:p>
                  <a:p>
                    <a:r>
                      <a:rPr lang="en-AU" sz="1600" dirty="0"/>
                      <a:t>LRPB FLANKER</a:t>
                    </a:r>
                  </a:p>
                  <a:p>
                    <a:r>
                      <a:rPr lang="en-AU" sz="1600" dirty="0"/>
                      <a:t>LRPB MUSTANG</a:t>
                    </a:r>
                  </a:p>
                  <a:p>
                    <a:r>
                      <a:rPr lang="en-AU" sz="1600" dirty="0"/>
                      <a:t>SUNSOFT98</a:t>
                    </a:r>
                  </a:p>
                  <a:p>
                    <a:r>
                      <a:rPr lang="en-AU" sz="1600" dirty="0"/>
                      <a:t>LRPB IMPALA</a:t>
                    </a:r>
                  </a:p>
                  <a:p>
                    <a:r>
                      <a:rPr lang="en-AU" sz="1600" dirty="0"/>
                      <a:t>QAL2000</a:t>
                    </a:r>
                  </a:p>
                </p:txBody>
              </p:sp>
              <p:sp>
                <p:nvSpPr>
                  <p:cNvPr id="13" name="Oval 12">
                    <a:extLst>
                      <a:ext uri="{FF2B5EF4-FFF2-40B4-BE49-F238E27FC236}">
                        <a16:creationId xmlns:a16="http://schemas.microsoft.com/office/drawing/2014/main" id="{9BB3C8B3-FA98-4994-BE0F-B634F7E28BC1}"/>
                      </a:ext>
                    </a:extLst>
                  </p:cNvPr>
                  <p:cNvSpPr/>
                  <p:nvPr/>
                </p:nvSpPr>
                <p:spPr>
                  <a:xfrm>
                    <a:off x="2125623" y="3253563"/>
                    <a:ext cx="180753" cy="175437"/>
                  </a:xfrm>
                  <a:prstGeom prst="ellipse">
                    <a:avLst/>
                  </a:prstGeom>
                  <a:solidFill>
                    <a:srgbClr val="0066CC"/>
                  </a:solidFill>
                  <a:ln>
                    <a:solidFill>
                      <a:schemeClr val="accent1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AU"/>
                  </a:p>
                </p:txBody>
              </p:sp>
              <p:sp>
                <p:nvSpPr>
                  <p:cNvPr id="14" name="Oval 13">
                    <a:extLst>
                      <a:ext uri="{FF2B5EF4-FFF2-40B4-BE49-F238E27FC236}">
                        <a16:creationId xmlns:a16="http://schemas.microsoft.com/office/drawing/2014/main" id="{C6F7A9FE-9542-4ACB-BBCD-889C254E210F}"/>
                      </a:ext>
                    </a:extLst>
                  </p:cNvPr>
                  <p:cNvSpPr/>
                  <p:nvPr/>
                </p:nvSpPr>
                <p:spPr>
                  <a:xfrm>
                    <a:off x="2125623" y="3528180"/>
                    <a:ext cx="180753" cy="175437"/>
                  </a:xfrm>
                  <a:prstGeom prst="ellipse">
                    <a:avLst/>
                  </a:prstGeom>
                  <a:solidFill>
                    <a:srgbClr val="EA6C16"/>
                  </a:solidFill>
                  <a:ln>
                    <a:solidFill>
                      <a:schemeClr val="accent2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AU"/>
                  </a:p>
                </p:txBody>
              </p:sp>
              <p:sp>
                <p:nvSpPr>
                  <p:cNvPr id="15" name="Oval 14">
                    <a:extLst>
                      <a:ext uri="{FF2B5EF4-FFF2-40B4-BE49-F238E27FC236}">
                        <a16:creationId xmlns:a16="http://schemas.microsoft.com/office/drawing/2014/main" id="{CDAC8E5F-A8C7-4511-AB32-6A29E6E6DFF8}"/>
                      </a:ext>
                    </a:extLst>
                  </p:cNvPr>
                  <p:cNvSpPr/>
                  <p:nvPr/>
                </p:nvSpPr>
                <p:spPr>
                  <a:xfrm>
                    <a:off x="2125623" y="3802797"/>
                    <a:ext cx="180753" cy="17543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AU"/>
                  </a:p>
                </p:txBody>
              </p:sp>
              <p:sp>
                <p:nvSpPr>
                  <p:cNvPr id="16" name="Oval 15">
                    <a:extLst>
                      <a:ext uri="{FF2B5EF4-FFF2-40B4-BE49-F238E27FC236}">
                        <a16:creationId xmlns:a16="http://schemas.microsoft.com/office/drawing/2014/main" id="{99108FAC-F600-4C14-B18F-3240CDC855AF}"/>
                      </a:ext>
                    </a:extLst>
                  </p:cNvPr>
                  <p:cNvSpPr/>
                  <p:nvPr/>
                </p:nvSpPr>
                <p:spPr>
                  <a:xfrm>
                    <a:off x="2125623" y="4077414"/>
                    <a:ext cx="180753" cy="175437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solidFill>
                      <a:schemeClr val="accent4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AU"/>
                  </a:p>
                </p:txBody>
              </p:sp>
              <p:sp>
                <p:nvSpPr>
                  <p:cNvPr id="17" name="Oval 16">
                    <a:extLst>
                      <a:ext uri="{FF2B5EF4-FFF2-40B4-BE49-F238E27FC236}">
                        <a16:creationId xmlns:a16="http://schemas.microsoft.com/office/drawing/2014/main" id="{DC42843C-B786-48E1-83ED-2C3A7E10047D}"/>
                      </a:ext>
                    </a:extLst>
                  </p:cNvPr>
                  <p:cNvSpPr/>
                  <p:nvPr/>
                </p:nvSpPr>
                <p:spPr>
                  <a:xfrm>
                    <a:off x="2125623" y="4352031"/>
                    <a:ext cx="180753" cy="175437"/>
                  </a:xfrm>
                  <a:prstGeom prst="ellipse">
                    <a:avLst/>
                  </a:prstGeom>
                  <a:solidFill>
                    <a:schemeClr val="accent1">
                      <a:lumMod val="60000"/>
                      <a:lumOff val="40000"/>
                    </a:schemeClr>
                  </a:solidFill>
                  <a:ln>
                    <a:solidFill>
                      <a:schemeClr val="accent5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AU"/>
                  </a:p>
                </p:txBody>
              </p:sp>
              <p:sp>
                <p:nvSpPr>
                  <p:cNvPr id="18" name="Oval 17">
                    <a:extLst>
                      <a:ext uri="{FF2B5EF4-FFF2-40B4-BE49-F238E27FC236}">
                        <a16:creationId xmlns:a16="http://schemas.microsoft.com/office/drawing/2014/main" id="{D69A125B-DE4E-4392-908E-A3EA5C4EFF03}"/>
                      </a:ext>
                    </a:extLst>
                  </p:cNvPr>
                  <p:cNvSpPr/>
                  <p:nvPr/>
                </p:nvSpPr>
                <p:spPr>
                  <a:xfrm>
                    <a:off x="2125623" y="4626646"/>
                    <a:ext cx="180753" cy="175437"/>
                  </a:xfrm>
                  <a:prstGeom prst="ellipse">
                    <a:avLst/>
                  </a:prstGeom>
                  <a:solidFill>
                    <a:srgbClr val="993366"/>
                  </a:solidFill>
                  <a:ln>
                    <a:solidFill>
                      <a:srgbClr val="660066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AU"/>
                  </a:p>
                </p:txBody>
              </p:sp>
            </p:grpSp>
          </p:grp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BCB663D-681F-4BA7-A277-03BAADCF2DC5}"/>
                  </a:ext>
                </a:extLst>
              </p:cNvPr>
              <p:cNvSpPr txBox="1"/>
              <p:nvPr/>
            </p:nvSpPr>
            <p:spPr>
              <a:xfrm>
                <a:off x="94062" y="267391"/>
                <a:ext cx="6661740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AU" sz="1200" b="1" u="sng" dirty="0"/>
                  <a:t>Legend</a:t>
                </a:r>
                <a:r>
                  <a:rPr lang="en-AU" sz="1200" dirty="0"/>
                  <a:t>: </a:t>
                </a:r>
              </a:p>
              <a:p>
                <a:r>
                  <a:rPr lang="en-AU" sz="1200" dirty="0"/>
                  <a:t>PCA plot (PC1 x PC2) based on LC-MS quantitative data. An amount of 20 mg (+/- 0.2 mg) from 6 wheat cultivars (</a:t>
                </a:r>
                <a:r>
                  <a:rPr lang="en-AU" sz="1200" dirty="0" err="1"/>
                  <a:t>Suntop</a:t>
                </a:r>
                <a:r>
                  <a:rPr lang="en-AU" sz="1200" dirty="0"/>
                  <a:t>, LRPB Flanker, LRPB Mustang, Sunsoft98, LRPB Impala, Qal2000) was weighed in four replicates, and extracted using 0.5 mL </a:t>
                </a:r>
                <a:r>
                  <a:rPr lang="en-AU" sz="1200" dirty="0" err="1"/>
                  <a:t>Gnd</a:t>
                </a:r>
                <a:r>
                  <a:rPr lang="en-AU" sz="1200" dirty="0"/>
                  <a:t>-HCl or urea buffer. and 10 </a:t>
                </a:r>
                <a:r>
                  <a:rPr lang="en-AU" sz="1200" dirty="0" err="1"/>
                  <a:t>uL</a:t>
                </a:r>
                <a:r>
                  <a:rPr lang="en-AU" sz="1200" dirty="0"/>
                  <a:t> extract aliquots were digested using trypsin/Lys-C protease mixture. LC-MS/MS data was acquired using LC method 6. NOTE: </a:t>
                </a:r>
                <a:r>
                  <a:rPr lang="en-AU" sz="1200" dirty="0" err="1"/>
                  <a:t>Suntop</a:t>
                </a:r>
                <a:r>
                  <a:rPr lang="en-AU" sz="1200" dirty="0"/>
                  <a:t> has 4 replicates; 2 of them (the very top ones) are so similar that they almost completely overlap.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504972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28A7846-4E6B-4693-8DF2-A6B42D5BEEFC}"/>
              </a:ext>
            </a:extLst>
          </p:cNvPr>
          <p:cNvGrpSpPr/>
          <p:nvPr/>
        </p:nvGrpSpPr>
        <p:grpSpPr>
          <a:xfrm>
            <a:off x="0" y="0"/>
            <a:ext cx="11363027" cy="6858000"/>
            <a:chOff x="0" y="0"/>
            <a:chExt cx="11363027" cy="685800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227341B-870D-4B59-833A-5002E6B056E4}"/>
                </a:ext>
              </a:extLst>
            </p:cNvPr>
            <p:cNvSpPr txBox="1"/>
            <p:nvPr/>
          </p:nvSpPr>
          <p:spPr>
            <a:xfrm>
              <a:off x="0" y="0"/>
              <a:ext cx="88684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/>
                <a:t>Vincent et al - Supplementary Figure S2: List of KEGG pathways using the mapper reconstruct with 3115 KO identifiers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7272CE2-A257-47C5-B9DE-7A0F803E1B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098" y="276998"/>
              <a:ext cx="3729563" cy="658100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C71E6D20-3DF8-4D5B-B92D-228B7066ED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582"/>
            <a:stretch/>
          </p:blipFill>
          <p:spPr>
            <a:xfrm>
              <a:off x="3006253" y="914399"/>
              <a:ext cx="3047955" cy="59436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3276212-8B3E-4804-9ABB-26CA0646E6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039"/>
            <a:stretch/>
          </p:blipFill>
          <p:spPr>
            <a:xfrm>
              <a:off x="6137794" y="914399"/>
              <a:ext cx="2740880" cy="5943601"/>
            </a:xfrm>
            <a:prstGeom prst="rect">
              <a:avLst/>
            </a:prstGeom>
          </p:spPr>
        </p:pic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501A6D2C-359C-4D66-946E-801A86ECBC0B}"/>
                </a:ext>
              </a:extLst>
            </p:cNvPr>
            <p:cNvGrpSpPr/>
            <p:nvPr/>
          </p:nvGrpSpPr>
          <p:grpSpPr>
            <a:xfrm>
              <a:off x="9046363" y="0"/>
              <a:ext cx="2316664" cy="6857999"/>
              <a:chOff x="8105505" y="-649998"/>
              <a:chExt cx="2036429" cy="6951645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0DD6FBBC-DF03-4D1E-AD66-84D50438B6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/>
              <a:stretch/>
            </p:blipFill>
            <p:spPr>
              <a:xfrm>
                <a:off x="8105505" y="3040654"/>
                <a:ext cx="2036429" cy="3260993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342AAAA4-E541-4A4D-B80C-9A3E8EF6FB5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4357" t="1" b="272"/>
              <a:stretch/>
            </p:blipFill>
            <p:spPr>
              <a:xfrm>
                <a:off x="8105505" y="-649998"/>
                <a:ext cx="1902239" cy="5943601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9940753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B5074E2E-3BBC-4E37-A879-AB6B782A6137}"/>
              </a:ext>
            </a:extLst>
          </p:cNvPr>
          <p:cNvGrpSpPr/>
          <p:nvPr/>
        </p:nvGrpSpPr>
        <p:grpSpPr>
          <a:xfrm>
            <a:off x="0" y="0"/>
            <a:ext cx="12192001" cy="6169314"/>
            <a:chOff x="0" y="0"/>
            <a:chExt cx="12192001" cy="616931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FD4B7B1-E225-4647-BB8B-E7BAC5D9D8EE}"/>
                </a:ext>
              </a:extLst>
            </p:cNvPr>
            <p:cNvSpPr txBox="1"/>
            <p:nvPr/>
          </p:nvSpPr>
          <p:spPr>
            <a:xfrm>
              <a:off x="1" y="0"/>
              <a:ext cx="12192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/>
                <a:t>Vincent et al - Supplementary Figure S3: KEGG mapper reconstruct with 3,115 KO identifiers from wheat flour. </a:t>
              </a:r>
              <a:r>
                <a:rPr lang="en-AU" sz="1400" dirty="0"/>
                <a:t>Proteins identified in this study are highlighted in green. A, Starch and sucrose metabolism (KEGG map00500); B, Plant-pathogen interaction (KEGG map 04626).  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5C72250-F547-4452-9A88-ED67640076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48375" y="3627595"/>
              <a:ext cx="95250" cy="95250"/>
            </a:xfrm>
            <a:prstGeom prst="rect">
              <a:avLst/>
            </a:prstGeom>
          </p:spPr>
        </p:pic>
        <p:pic>
          <p:nvPicPr>
            <p:cNvPr id="6" name="Picture 5" descr="Diagram, schematic&#10;&#10;Description automatically generated">
              <a:extLst>
                <a:ext uri="{FF2B5EF4-FFF2-40B4-BE49-F238E27FC236}">
                  <a16:creationId xmlns:a16="http://schemas.microsoft.com/office/drawing/2014/main" id="{AA622C3F-8157-44DD-95FB-D27C42C0C7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150" y="523220"/>
              <a:ext cx="6646470" cy="411424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505E475-3B8D-4053-81F3-E5281C5E4D55}"/>
                </a:ext>
              </a:extLst>
            </p:cNvPr>
            <p:cNvSpPr txBox="1"/>
            <p:nvPr/>
          </p:nvSpPr>
          <p:spPr>
            <a:xfrm>
              <a:off x="0" y="456120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A</a:t>
              </a:r>
            </a:p>
          </p:txBody>
        </p:sp>
        <p:pic>
          <p:nvPicPr>
            <p:cNvPr id="8" name="Picture 7" descr="Diagram&#10;&#10;Description automatically generated">
              <a:extLst>
                <a:ext uri="{FF2B5EF4-FFF2-40B4-BE49-F238E27FC236}">
                  <a16:creationId xmlns:a16="http://schemas.microsoft.com/office/drawing/2014/main" id="{AE336FF8-0222-47A5-98B4-DBD73E2A3C7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60770" y="523426"/>
              <a:ext cx="5312821" cy="564588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EA2363F-D87A-4571-A341-1B5650924BD6}"/>
                </a:ext>
              </a:extLst>
            </p:cNvPr>
            <p:cNvSpPr txBox="1"/>
            <p:nvPr/>
          </p:nvSpPr>
          <p:spPr>
            <a:xfrm>
              <a:off x="6703620" y="456120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352910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>
            <a:extLst>
              <a:ext uri="{FF2B5EF4-FFF2-40B4-BE49-F238E27FC236}">
                <a16:creationId xmlns:a16="http://schemas.microsoft.com/office/drawing/2014/main" id="{FEAA944A-077F-4A28-920A-45600A56F343}"/>
              </a:ext>
            </a:extLst>
          </p:cNvPr>
          <p:cNvGrpSpPr/>
          <p:nvPr/>
        </p:nvGrpSpPr>
        <p:grpSpPr>
          <a:xfrm>
            <a:off x="53165" y="0"/>
            <a:ext cx="7747570" cy="6721113"/>
            <a:chOff x="53165" y="0"/>
            <a:chExt cx="7747570" cy="6721113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EB72AFBB-ADD3-4335-A440-1AE9CAFED6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8592" y="2287572"/>
              <a:ext cx="5958039" cy="443354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9B98F3A-E1B3-485A-84E2-674FCA731F30}"/>
                </a:ext>
              </a:extLst>
            </p:cNvPr>
            <p:cNvSpPr txBox="1"/>
            <p:nvPr/>
          </p:nvSpPr>
          <p:spPr>
            <a:xfrm>
              <a:off x="53165" y="0"/>
              <a:ext cx="77475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/>
                <a:t>Vincent et al - Supplementary Figure S4: </a:t>
              </a:r>
              <a:r>
                <a:rPr lang="en-AU" sz="1400" b="1" dirty="0" err="1"/>
                <a:t>UniprotKB</a:t>
              </a:r>
              <a:r>
                <a:rPr lang="en-AU" sz="1400" b="1" dirty="0"/>
                <a:t> Retrieve/ID mapping using 8738 uniport accessions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9F6758A-DA77-42E1-8071-3E9E3672435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7960" y="307777"/>
              <a:ext cx="5958039" cy="16886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0DDDCA2-5AFA-4A20-BCD3-ECB4F5B37159}"/>
                </a:ext>
              </a:extLst>
            </p:cNvPr>
            <p:cNvSpPr/>
            <p:nvPr/>
          </p:nvSpPr>
          <p:spPr>
            <a:xfrm>
              <a:off x="127328" y="2052273"/>
              <a:ext cx="5968672" cy="46585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EA7FBE1-6ECB-4133-9697-E63CD8E21AD4}"/>
                </a:ext>
              </a:extLst>
            </p:cNvPr>
            <p:cNvSpPr txBox="1"/>
            <p:nvPr/>
          </p:nvSpPr>
          <p:spPr>
            <a:xfrm>
              <a:off x="148592" y="2062518"/>
              <a:ext cx="21098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b="1" dirty="0">
                  <a:solidFill>
                    <a:srgbClr val="00709B"/>
                  </a:solidFill>
                  <a:latin typeface="Arial Black" panose="020B0A04020102020204" pitchFamily="34" charset="0"/>
                </a:rPr>
                <a:t>GO Molecular Function</a:t>
              </a:r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78049C12-0380-45EE-8985-D608FAA61F77}"/>
                </a:ext>
              </a:extLst>
            </p:cNvPr>
            <p:cNvGrpSpPr/>
            <p:nvPr/>
          </p:nvGrpSpPr>
          <p:grpSpPr>
            <a:xfrm>
              <a:off x="3083443" y="1084519"/>
              <a:ext cx="308344" cy="1073890"/>
              <a:chOff x="3083443" y="1084519"/>
              <a:chExt cx="308344" cy="1339704"/>
            </a:xfrm>
          </p:grpSpPr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6DA04E4F-73B6-4EFA-8788-18C19E3C34A7}"/>
                  </a:ext>
                </a:extLst>
              </p:cNvPr>
              <p:cNvCxnSpPr/>
              <p:nvPr/>
            </p:nvCxnSpPr>
            <p:spPr>
              <a:xfrm>
                <a:off x="3083443" y="1105786"/>
                <a:ext cx="308344" cy="0"/>
              </a:xfrm>
              <a:prstGeom prst="line">
                <a:avLst/>
              </a:prstGeom>
              <a:ln w="76200">
                <a:solidFill>
                  <a:srgbClr val="66A9C3"/>
                </a:solidFill>
              </a:ln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54C4EE53-FD8F-47FC-B1BD-0BC74E2AFF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59888" y="1084519"/>
                <a:ext cx="0" cy="1339704"/>
              </a:xfrm>
              <a:prstGeom prst="straightConnector1">
                <a:avLst/>
              </a:prstGeom>
              <a:ln w="76200">
                <a:solidFill>
                  <a:srgbClr val="66A9C3"/>
                </a:solidFill>
                <a:tailEnd type="triangle"/>
              </a:ln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6524094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ECF6F3C9-3636-4D6A-B649-197B9F0AB58B}"/>
              </a:ext>
            </a:extLst>
          </p:cNvPr>
          <p:cNvGrpSpPr/>
          <p:nvPr/>
        </p:nvGrpSpPr>
        <p:grpSpPr>
          <a:xfrm>
            <a:off x="0" y="-3833"/>
            <a:ext cx="12192000" cy="6861833"/>
            <a:chOff x="0" y="-3833"/>
            <a:chExt cx="12192000" cy="6861833"/>
          </a:xfrm>
        </p:grpSpPr>
        <p:pic>
          <p:nvPicPr>
            <p:cNvPr id="6" name="Picture 5" descr="Diagram&#10;&#10;Description automatically generated">
              <a:extLst>
                <a:ext uri="{FF2B5EF4-FFF2-40B4-BE49-F238E27FC236}">
                  <a16:creationId xmlns:a16="http://schemas.microsoft.com/office/drawing/2014/main" id="{B90EBC5A-9A3F-49E5-848E-96FDC9F976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35934" y="448328"/>
              <a:ext cx="8056066" cy="4921624"/>
            </a:xfrm>
            <a:prstGeom prst="rect">
              <a:avLst/>
            </a:prstGeom>
          </p:spPr>
        </p:pic>
        <p:pic>
          <p:nvPicPr>
            <p:cNvPr id="8" name="Picture 7" descr="Diagram&#10;&#10;Description automatically generated">
              <a:extLst>
                <a:ext uri="{FF2B5EF4-FFF2-40B4-BE49-F238E27FC236}">
                  <a16:creationId xmlns:a16="http://schemas.microsoft.com/office/drawing/2014/main" id="{553C9C55-8D8B-40E7-BBF9-FFD991916A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79879" y="3200400"/>
              <a:ext cx="3995991" cy="3657600"/>
            </a:xfrm>
            <a:prstGeom prst="rect">
              <a:avLst/>
            </a:prstGeom>
          </p:spPr>
        </p:pic>
        <p:pic>
          <p:nvPicPr>
            <p:cNvPr id="10" name="Picture 9" descr="Diagram&#10;&#10;Description automatically generated">
              <a:extLst>
                <a:ext uri="{FF2B5EF4-FFF2-40B4-BE49-F238E27FC236}">
                  <a16:creationId xmlns:a16="http://schemas.microsoft.com/office/drawing/2014/main" id="{78E994E6-A606-44CB-AE3C-DFB097A6B11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651" y="543203"/>
              <a:ext cx="3355576" cy="4130286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3810BF0-6A7B-4D27-9F1B-6B46F11C8ABE}"/>
                </a:ext>
              </a:extLst>
            </p:cNvPr>
            <p:cNvSpPr txBox="1"/>
            <p:nvPr/>
          </p:nvSpPr>
          <p:spPr>
            <a:xfrm>
              <a:off x="0" y="-3833"/>
              <a:ext cx="64523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/>
                <a:t>Vincent et - Supplementary Figure S5: GO hieratical diagram from 753 </a:t>
              </a:r>
              <a:r>
                <a:rPr lang="en-AU" sz="1400" b="1" dirty="0" err="1"/>
                <a:t>AgriGO</a:t>
              </a:r>
              <a:r>
                <a:rPr lang="en-AU" sz="1400" b="1" dirty="0"/>
                <a:t> terms.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A574900-912E-48CB-B91A-2C56710D7344}"/>
                </a:ext>
              </a:extLst>
            </p:cNvPr>
            <p:cNvSpPr txBox="1"/>
            <p:nvPr/>
          </p:nvSpPr>
          <p:spPr>
            <a:xfrm>
              <a:off x="556861" y="345776"/>
              <a:ext cx="18309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 Black" panose="020B0A04020102020204" pitchFamily="34" charset="0"/>
                </a:rPr>
                <a:t>A. Molecular function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CD3FC58-33BE-4EAE-BA2B-F39DC3017AA7}"/>
                </a:ext>
              </a:extLst>
            </p:cNvPr>
            <p:cNvSpPr txBox="1"/>
            <p:nvPr/>
          </p:nvSpPr>
          <p:spPr>
            <a:xfrm>
              <a:off x="3209793" y="3002973"/>
              <a:ext cx="18934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 Black" panose="020B0A04020102020204" pitchFamily="34" charset="0"/>
                </a:rPr>
                <a:t>C. Cellular componen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7A9EFFD-1B2F-4919-81FF-405E2314D5AE}"/>
                </a:ext>
              </a:extLst>
            </p:cNvPr>
            <p:cNvSpPr txBox="1"/>
            <p:nvPr/>
          </p:nvSpPr>
          <p:spPr>
            <a:xfrm>
              <a:off x="7033243" y="245783"/>
              <a:ext cx="18149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 Black" panose="020B0A04020102020204" pitchFamily="34" charset="0"/>
                </a:rPr>
                <a:t>B. Biological proces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C3231E5-8DD8-42D2-BA33-AAD2C424F4AF}"/>
                </a:ext>
              </a:extLst>
            </p:cNvPr>
            <p:cNvSpPr txBox="1"/>
            <p:nvPr/>
          </p:nvSpPr>
          <p:spPr>
            <a:xfrm>
              <a:off x="6475495" y="5987160"/>
              <a:ext cx="5552823" cy="7694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just"/>
              <a:r>
                <a:rPr lang="en-AU" sz="1100" u="sng" dirty="0"/>
                <a:t>Legend</a:t>
              </a:r>
              <a:r>
                <a:rPr lang="en-AU" sz="1100" dirty="0"/>
                <a:t>: The smaller of the term's adjusted p-value, the more significant statistically, and the node's </a:t>
              </a:r>
              <a:r>
                <a:rPr lang="en-AU" sz="1100" dirty="0" err="1"/>
                <a:t>color</a:t>
              </a:r>
              <a:r>
                <a:rPr lang="en-AU" sz="1100" dirty="0"/>
                <a:t> is darker and redder. Inside the box of the significant terms, the information includes: GO term, adjusted p-value, GO description, item number mapping the GO in the query list and background, and total number of query list and background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917053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F1BAA69-51AD-4238-A125-9C2CC2F81529}"/>
              </a:ext>
            </a:extLst>
          </p:cNvPr>
          <p:cNvGrpSpPr/>
          <p:nvPr/>
        </p:nvGrpSpPr>
        <p:grpSpPr>
          <a:xfrm>
            <a:off x="-36096" y="-48030"/>
            <a:ext cx="12200569" cy="6906031"/>
            <a:chOff x="-36096" y="-48030"/>
            <a:chExt cx="12200569" cy="6906031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EEA9F9C-5EC0-4466-A01B-1645F0E81B78}"/>
                </a:ext>
              </a:extLst>
            </p:cNvPr>
            <p:cNvSpPr txBox="1"/>
            <p:nvPr/>
          </p:nvSpPr>
          <p:spPr>
            <a:xfrm>
              <a:off x="-36096" y="-48030"/>
              <a:ext cx="75709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/>
                <a:t>Vincent et - Supplementary Figure S6: GO classification summary using REVIGO and 3000 GO terms.</a:t>
              </a:r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CBDE2FF1-B8BD-4EAB-ABCA-12B0F9BC1EBF}"/>
                </a:ext>
              </a:extLst>
            </p:cNvPr>
            <p:cNvGrpSpPr/>
            <p:nvPr/>
          </p:nvGrpSpPr>
          <p:grpSpPr>
            <a:xfrm>
              <a:off x="-10987" y="171519"/>
              <a:ext cx="12175460" cy="6686482"/>
              <a:chOff x="-10987" y="171519"/>
              <a:chExt cx="12175460" cy="6686482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86F21F0-27C1-438A-BD12-7E29C273BBCA}"/>
                  </a:ext>
                </a:extLst>
              </p:cNvPr>
              <p:cNvSpPr txBox="1"/>
              <p:nvPr/>
            </p:nvSpPr>
            <p:spPr>
              <a:xfrm>
                <a:off x="1235329" y="171519"/>
                <a:ext cx="18764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Biological process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7B7F24C-A88D-4C1C-B400-8EBD41FEF505}"/>
                  </a:ext>
                </a:extLst>
              </p:cNvPr>
              <p:cNvSpPr txBox="1"/>
              <p:nvPr/>
            </p:nvSpPr>
            <p:spPr>
              <a:xfrm>
                <a:off x="9292878" y="171519"/>
                <a:ext cx="208210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Cellular Component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911687F-14D2-4044-8419-1A67CEA3EBBB}"/>
                  </a:ext>
                </a:extLst>
              </p:cNvPr>
              <p:cNvSpPr txBox="1"/>
              <p:nvPr/>
            </p:nvSpPr>
            <p:spPr>
              <a:xfrm>
                <a:off x="5183473" y="171519"/>
                <a:ext cx="203773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Molecular Function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1E18030-7B8D-4314-B99D-4B29ABFDB91B}"/>
                  </a:ext>
                </a:extLst>
              </p:cNvPr>
              <p:cNvSpPr txBox="1"/>
              <p:nvPr/>
            </p:nvSpPr>
            <p:spPr>
              <a:xfrm rot="16200000">
                <a:off x="-443958" y="1781151"/>
                <a:ext cx="12352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Scatterplot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17B2F0B-8F3E-40FC-B108-B0AB6E77C08D}"/>
                  </a:ext>
                </a:extLst>
              </p:cNvPr>
              <p:cNvSpPr txBox="1"/>
              <p:nvPr/>
            </p:nvSpPr>
            <p:spPr>
              <a:xfrm rot="16200000">
                <a:off x="-370701" y="5066882"/>
                <a:ext cx="108876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Tree Map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1ADB78AE-281C-45F4-B227-E1C0266DC0BE}"/>
                  </a:ext>
                </a:extLst>
              </p:cNvPr>
              <p:cNvSpPr/>
              <p:nvPr/>
            </p:nvSpPr>
            <p:spPr>
              <a:xfrm>
                <a:off x="40943" y="232013"/>
                <a:ext cx="12123530" cy="6625988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FD41B00E-63C8-45C2-8DDC-8DA8776C93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01885" y="568147"/>
                <a:ext cx="3790643" cy="3051726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0F4E3BE-CCCE-476C-9772-8B486DF7DF05}"/>
                  </a:ext>
                </a:extLst>
              </p:cNvPr>
              <p:cNvSpPr txBox="1"/>
              <p:nvPr/>
            </p:nvSpPr>
            <p:spPr>
              <a:xfrm>
                <a:off x="3846984" y="448041"/>
                <a:ext cx="34932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800" b="1" dirty="0"/>
                  <a:t>A</a:t>
                </a:r>
              </a:p>
            </p:txBody>
          </p:sp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D3D3A494-CECC-4E01-9F4C-93F4A04E25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78333" y="3899426"/>
                <a:ext cx="3932784" cy="2951917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B086994-E581-4B2B-BC52-8EC548B38121}"/>
                  </a:ext>
                </a:extLst>
              </p:cNvPr>
              <p:cNvSpPr txBox="1"/>
              <p:nvPr/>
            </p:nvSpPr>
            <p:spPr>
              <a:xfrm>
                <a:off x="3856322" y="3543031"/>
                <a:ext cx="41069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800" b="1" dirty="0"/>
                  <a:t>D</a:t>
                </a:r>
              </a:p>
            </p:txBody>
          </p:sp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96A85C69-F9F2-4E67-B0E8-42DF311193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343941" y="548534"/>
                <a:ext cx="3794427" cy="3058725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AAF9D9E-5F6D-401C-AA09-E875049352A9}"/>
                  </a:ext>
                </a:extLst>
              </p:cNvPr>
              <p:cNvSpPr txBox="1"/>
              <p:nvPr/>
            </p:nvSpPr>
            <p:spPr>
              <a:xfrm>
                <a:off x="7796261" y="456022"/>
                <a:ext cx="386644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800" b="1" dirty="0"/>
                  <a:t>B</a:t>
                </a:r>
              </a:p>
            </p:txBody>
          </p:sp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7A3172C5-A0DE-4471-9FFD-14351894C3D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316068" y="3895996"/>
                <a:ext cx="3948048" cy="2955347"/>
              </a:xfrm>
              <a:prstGeom prst="rect">
                <a:avLst/>
              </a:prstGeom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66F0ADBC-EEAE-423B-B230-94CFC70529F5}"/>
                  </a:ext>
                </a:extLst>
              </p:cNvPr>
              <p:cNvSpPr txBox="1"/>
              <p:nvPr/>
            </p:nvSpPr>
            <p:spPr>
              <a:xfrm>
                <a:off x="7765527" y="3556791"/>
                <a:ext cx="359394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800" b="1" dirty="0"/>
                  <a:t>E</a:t>
                </a:r>
              </a:p>
            </p:txBody>
          </p:sp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15D6B7A2-1306-4A18-9117-D0B44F44E3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311097" y="552245"/>
                <a:ext cx="3794427" cy="3056744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37FF1CFA-388F-4FAD-B9C6-714181DC8187}"/>
                  </a:ext>
                </a:extLst>
              </p:cNvPr>
              <p:cNvSpPr txBox="1"/>
              <p:nvPr/>
            </p:nvSpPr>
            <p:spPr>
              <a:xfrm>
                <a:off x="11763417" y="435906"/>
                <a:ext cx="375424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800" b="1" dirty="0"/>
                  <a:t>C</a:t>
                </a:r>
              </a:p>
            </p:txBody>
          </p:sp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AABB89E9-0845-44A4-8D80-9D13917471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285120" y="3886072"/>
                <a:ext cx="3848934" cy="2962988"/>
              </a:xfrm>
              <a:prstGeom prst="rect">
                <a:avLst/>
              </a:prstGeom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8A3DF97-01C7-4FE5-80E5-F00EACB16558}"/>
                  </a:ext>
                </a:extLst>
              </p:cNvPr>
              <p:cNvSpPr txBox="1"/>
              <p:nvPr/>
            </p:nvSpPr>
            <p:spPr>
              <a:xfrm>
                <a:off x="11768654" y="3539496"/>
                <a:ext cx="300311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2800" b="1" dirty="0"/>
                  <a:t>F</a:t>
                </a:r>
              </a:p>
            </p:txBody>
          </p: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C37FABFA-DCD7-419C-8C8E-FCD490F242A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7527" y="490108"/>
                <a:ext cx="12136946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4A3C756A-4037-4975-940C-4EB651147D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6928" y="232011"/>
                <a:ext cx="0" cy="6625989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6D5381DA-9DD8-4094-B9C2-BC0B004E1BB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59166" y="232011"/>
                <a:ext cx="0" cy="6625988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EE811C33-C33F-48EC-AB57-A766E757D1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0126" y="232012"/>
                <a:ext cx="0" cy="6625988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500A6B12-11AE-4323-9118-5AA9AFF186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958" y="3645311"/>
                <a:ext cx="12136946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7118575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74">
            <a:extLst>
              <a:ext uri="{FF2B5EF4-FFF2-40B4-BE49-F238E27FC236}">
                <a16:creationId xmlns:a16="http://schemas.microsoft.com/office/drawing/2014/main" id="{D2B2A028-22B9-473A-A599-D96A05410FF2}"/>
              </a:ext>
            </a:extLst>
          </p:cNvPr>
          <p:cNvGrpSpPr/>
          <p:nvPr/>
        </p:nvGrpSpPr>
        <p:grpSpPr>
          <a:xfrm>
            <a:off x="-13106" y="-27897"/>
            <a:ext cx="12169010" cy="6869894"/>
            <a:chOff x="-13106" y="-27897"/>
            <a:chExt cx="12169010" cy="686989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3810BF0-6A7B-4D27-9F1B-6B46F11C8ABE}"/>
                </a:ext>
              </a:extLst>
            </p:cNvPr>
            <p:cNvSpPr txBox="1"/>
            <p:nvPr/>
          </p:nvSpPr>
          <p:spPr>
            <a:xfrm>
              <a:off x="0" y="-27897"/>
              <a:ext cx="72278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/>
                <a:t>Vincent et - Supplementary Figure S7: Pathway Tools omics analysis with 8288 </a:t>
              </a:r>
              <a:r>
                <a:rPr lang="en-AU" sz="1400" b="1" dirty="0" err="1"/>
                <a:t>Traes</a:t>
              </a:r>
              <a:r>
                <a:rPr lang="en-AU" sz="1400" b="1" dirty="0"/>
                <a:t> accessions.</a:t>
              </a:r>
            </a:p>
          </p:txBody>
        </p: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3FF1237C-7005-4465-8D50-808E355E2481}"/>
                </a:ext>
              </a:extLst>
            </p:cNvPr>
            <p:cNvGrpSpPr/>
            <p:nvPr/>
          </p:nvGrpSpPr>
          <p:grpSpPr>
            <a:xfrm>
              <a:off x="-13106" y="218325"/>
              <a:ext cx="12169010" cy="6623672"/>
              <a:chOff x="-13106" y="218325"/>
              <a:chExt cx="12169010" cy="6623672"/>
            </a:xfrm>
          </p:grpSpPr>
          <p:grpSp>
            <p:nvGrpSpPr>
              <p:cNvPr id="72" name="Group 71">
                <a:extLst>
                  <a:ext uri="{FF2B5EF4-FFF2-40B4-BE49-F238E27FC236}">
                    <a16:creationId xmlns:a16="http://schemas.microsoft.com/office/drawing/2014/main" id="{AF8726EF-0497-448F-847D-8ADB2D19DE6A}"/>
                  </a:ext>
                </a:extLst>
              </p:cNvPr>
              <p:cNvGrpSpPr/>
              <p:nvPr/>
            </p:nvGrpSpPr>
            <p:grpSpPr>
              <a:xfrm>
                <a:off x="-13106" y="218325"/>
                <a:ext cx="12169010" cy="6623672"/>
                <a:chOff x="47054" y="242389"/>
                <a:chExt cx="12169010" cy="6623672"/>
              </a:xfrm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B82C8D06-F4D1-44A2-B10B-8AD55EC3BB5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565831" y="4128785"/>
                  <a:ext cx="4281316" cy="2699654"/>
                </a:xfrm>
                <a:prstGeom prst="rect">
                  <a:avLst/>
                </a:prstGeom>
              </p:spPr>
            </p:pic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8E1EDC5E-5D30-4729-9AC5-424D19F40607}"/>
                    </a:ext>
                  </a:extLst>
                </p:cNvPr>
                <p:cNvSpPr txBox="1"/>
                <p:nvPr/>
              </p:nvSpPr>
              <p:spPr>
                <a:xfrm>
                  <a:off x="10847151" y="4141945"/>
                  <a:ext cx="1297796" cy="2708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1000" u="sng" dirty="0"/>
                    <a:t>Legend</a:t>
                  </a:r>
                  <a:r>
                    <a:rPr lang="en-AU" sz="1000" dirty="0"/>
                    <a:t>: 1949 (24%) out of 8288 </a:t>
                  </a:r>
                  <a:r>
                    <a:rPr lang="en-AU" sz="1000" dirty="0" err="1"/>
                    <a:t>Traes</a:t>
                  </a:r>
                  <a:r>
                    <a:rPr lang="en-AU" sz="1000" dirty="0"/>
                    <a:t> accessions were found in Pathway Tools within many pathways as can be seen in the whole Cellular Overview (A); zoom-in on Hormone biosynthesis (B); all the proteases used helped identify proteins involved in the same pathways as can be seen in the Omics dashboard (C). </a:t>
                  </a:r>
                </a:p>
              </p:txBody>
            </p:sp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182E47D3-644C-4D2E-975B-B352F807A1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33489" y="303944"/>
                  <a:ext cx="11849100" cy="3790950"/>
                </a:xfrm>
                <a:prstGeom prst="rect">
                  <a:avLst/>
                </a:prstGeom>
              </p:spPr>
            </p:pic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8E1CBE60-904C-4486-8796-F06E442DF4A8}"/>
                    </a:ext>
                  </a:extLst>
                </p:cNvPr>
                <p:cNvSpPr txBox="1"/>
                <p:nvPr/>
              </p:nvSpPr>
              <p:spPr>
                <a:xfrm>
                  <a:off x="47054" y="242389"/>
                  <a:ext cx="3241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b="1" dirty="0"/>
                    <a:t>A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3AB7F9E2-B704-4DA8-97E5-39A0EE74259E}"/>
                    </a:ext>
                  </a:extLst>
                </p:cNvPr>
                <p:cNvSpPr txBox="1"/>
                <p:nvPr/>
              </p:nvSpPr>
              <p:spPr>
                <a:xfrm>
                  <a:off x="47054" y="4023588"/>
                  <a:ext cx="3241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b="1" dirty="0"/>
                    <a:t>B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5324FD83-36B2-4C96-9734-21E33148C132}"/>
                    </a:ext>
                  </a:extLst>
                </p:cNvPr>
                <p:cNvSpPr txBox="1"/>
                <p:nvPr/>
              </p:nvSpPr>
              <p:spPr>
                <a:xfrm>
                  <a:off x="6294538" y="4025377"/>
                  <a:ext cx="3064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b="1" dirty="0"/>
                    <a:t>C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FDE102E5-1815-4A66-8CF7-AB35F6CCC925}"/>
                    </a:ext>
                  </a:extLst>
                </p:cNvPr>
                <p:cNvSpPr txBox="1"/>
                <p:nvPr/>
              </p:nvSpPr>
              <p:spPr>
                <a:xfrm>
                  <a:off x="1850317" y="329846"/>
                  <a:ext cx="186781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00" dirty="0"/>
                    <a:t>Secondary metabolite biosynthesis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DF77CCC1-A23B-4A4F-9C25-83E48E5F481E}"/>
                    </a:ext>
                  </a:extLst>
                </p:cNvPr>
                <p:cNvSpPr txBox="1"/>
                <p:nvPr/>
              </p:nvSpPr>
              <p:spPr>
                <a:xfrm>
                  <a:off x="1934799" y="1342806"/>
                  <a:ext cx="926857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00" dirty="0"/>
                    <a:t>AA biosynthesis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171BA72F-9D4C-47BC-A3FB-39167D67A148}"/>
                    </a:ext>
                  </a:extLst>
                </p:cNvPr>
                <p:cNvSpPr txBox="1"/>
                <p:nvPr/>
              </p:nvSpPr>
              <p:spPr>
                <a:xfrm>
                  <a:off x="556524" y="1911418"/>
                  <a:ext cx="318869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00" dirty="0"/>
                    <a:t>Cofactor, prosthetic group, electron carrier, vitamin biosynthesis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A0FC0D5B-73B4-486A-970B-6E6B347F9A5C}"/>
                    </a:ext>
                  </a:extLst>
                </p:cNvPr>
                <p:cNvSpPr txBox="1"/>
                <p:nvPr/>
              </p:nvSpPr>
              <p:spPr>
                <a:xfrm>
                  <a:off x="810339" y="2550874"/>
                  <a:ext cx="123783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00" dirty="0"/>
                    <a:t>Hormone biosynthesis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EBCA4C9D-E06D-442B-B2FC-00F4F7B3CB7E}"/>
                    </a:ext>
                  </a:extLst>
                </p:cNvPr>
                <p:cNvSpPr txBox="1"/>
                <p:nvPr/>
              </p:nvSpPr>
              <p:spPr>
                <a:xfrm>
                  <a:off x="7385269" y="3547228"/>
                  <a:ext cx="145584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/>
                    <a:t>Inorganic nutrient metabolism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740952B9-2FBF-48DD-89BC-0FFBBF0D7960}"/>
                    </a:ext>
                  </a:extLst>
                </p:cNvPr>
                <p:cNvSpPr txBox="1"/>
                <p:nvPr/>
              </p:nvSpPr>
              <p:spPr>
                <a:xfrm>
                  <a:off x="2954448" y="2550874"/>
                  <a:ext cx="143500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00" dirty="0"/>
                    <a:t>Carbohydrate biosynthesis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2181ECA4-D0C5-4614-88EE-9AA23FDC6B8C}"/>
                    </a:ext>
                  </a:extLst>
                </p:cNvPr>
                <p:cNvSpPr txBox="1"/>
                <p:nvPr/>
              </p:nvSpPr>
              <p:spPr>
                <a:xfrm>
                  <a:off x="4066392" y="1421208"/>
                  <a:ext cx="113679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800" dirty="0"/>
                    <a:t>Amine and polyamine biosynthesis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1C511A03-95A6-4A27-BC42-19FEC0FB4A17}"/>
                    </a:ext>
                  </a:extLst>
                </p:cNvPr>
                <p:cNvSpPr txBox="1"/>
                <p:nvPr/>
              </p:nvSpPr>
              <p:spPr>
                <a:xfrm>
                  <a:off x="4090918" y="1911418"/>
                  <a:ext cx="93188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800" dirty="0"/>
                    <a:t>AA-tRNA charging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9AA2AC58-2FAE-4990-B695-828A44021516}"/>
                    </a:ext>
                  </a:extLst>
                </p:cNvPr>
                <p:cNvSpPr txBox="1"/>
                <p:nvPr/>
              </p:nvSpPr>
              <p:spPr>
                <a:xfrm>
                  <a:off x="5401669" y="319088"/>
                  <a:ext cx="134363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00" dirty="0"/>
                    <a:t>FA and lipid biosynthesis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2CEABD3B-B01F-490B-A20D-F90CCA8F32C6}"/>
                    </a:ext>
                  </a:extLst>
                </p:cNvPr>
                <p:cNvSpPr txBox="1"/>
                <p:nvPr/>
              </p:nvSpPr>
              <p:spPr>
                <a:xfrm>
                  <a:off x="5197271" y="2212370"/>
                  <a:ext cx="128272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/>
                    <a:t>Cell structure biosynthesis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BBF91932-81C4-4E35-A0B7-47478A93369D}"/>
                    </a:ext>
                  </a:extLst>
                </p:cNvPr>
                <p:cNvSpPr txBox="1"/>
                <p:nvPr/>
              </p:nvSpPr>
              <p:spPr>
                <a:xfrm>
                  <a:off x="5216450" y="2509389"/>
                  <a:ext cx="18373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/>
                    <a:t>Nucleoside and nucleotide biosynthesis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D9D39FE1-4B49-4080-849F-6AF0938E70F6}"/>
                    </a:ext>
                  </a:extLst>
                </p:cNvPr>
                <p:cNvSpPr txBox="1"/>
                <p:nvPr/>
              </p:nvSpPr>
              <p:spPr>
                <a:xfrm>
                  <a:off x="6154448" y="1217247"/>
                  <a:ext cx="117133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800" dirty="0"/>
                    <a:t>Aromatic compound biosynthesis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838F63C9-DD72-4809-9447-E3BF1F0F4EAB}"/>
                    </a:ext>
                  </a:extLst>
                </p:cNvPr>
                <p:cNvSpPr txBox="1"/>
                <p:nvPr/>
              </p:nvSpPr>
              <p:spPr>
                <a:xfrm>
                  <a:off x="6685815" y="720197"/>
                  <a:ext cx="8194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/>
                    <a:t>Photosynthesis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19EA4381-359B-47DE-853C-2B0B69E94B9B}"/>
                    </a:ext>
                  </a:extLst>
                </p:cNvPr>
                <p:cNvSpPr txBox="1"/>
                <p:nvPr/>
              </p:nvSpPr>
              <p:spPr>
                <a:xfrm>
                  <a:off x="6863668" y="1830463"/>
                  <a:ext cx="6110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 err="1"/>
                    <a:t>GLycolysis</a:t>
                  </a:r>
                  <a:endParaRPr lang="en-AU" sz="800" dirty="0"/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E43CC93D-A9E7-4017-99F6-F9D7BECC3BFF}"/>
                    </a:ext>
                  </a:extLst>
                </p:cNvPr>
                <p:cNvSpPr txBox="1"/>
                <p:nvPr/>
              </p:nvSpPr>
              <p:spPr>
                <a:xfrm>
                  <a:off x="7638381" y="312960"/>
                  <a:ext cx="83548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/>
                    <a:t>AA degradation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143333D7-39E4-40F2-B9F3-E7B9BF5B357E}"/>
                    </a:ext>
                  </a:extLst>
                </p:cNvPr>
                <p:cNvSpPr txBox="1"/>
                <p:nvPr/>
              </p:nvSpPr>
              <p:spPr>
                <a:xfrm>
                  <a:off x="7633735" y="1245842"/>
                  <a:ext cx="12073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/>
                    <a:t>FA and lipid degradation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5572B80D-0F22-4EA6-BD0E-3EB78490FDD4}"/>
                    </a:ext>
                  </a:extLst>
                </p:cNvPr>
                <p:cNvSpPr txBox="1"/>
                <p:nvPr/>
              </p:nvSpPr>
              <p:spPr>
                <a:xfrm>
                  <a:off x="9424814" y="256893"/>
                  <a:ext cx="18710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800" dirty="0"/>
                    <a:t>Reactions that are not part of a pathway</a:t>
                  </a:r>
                </a:p>
              </p:txBody>
            </p:sp>
            <p:grpSp>
              <p:nvGrpSpPr>
                <p:cNvPr id="65" name="Group 64">
                  <a:extLst>
                    <a:ext uri="{FF2B5EF4-FFF2-40B4-BE49-F238E27FC236}">
                      <a16:creationId xmlns:a16="http://schemas.microsoft.com/office/drawing/2014/main" id="{6DCBEAB4-8A14-4A6D-AD83-5D250AEA0DC5}"/>
                    </a:ext>
                  </a:extLst>
                </p:cNvPr>
                <p:cNvGrpSpPr/>
                <p:nvPr/>
              </p:nvGrpSpPr>
              <p:grpSpPr>
                <a:xfrm>
                  <a:off x="332846" y="4078984"/>
                  <a:ext cx="5961049" cy="2746308"/>
                  <a:chOff x="332846" y="4031359"/>
                  <a:chExt cx="5961049" cy="2746308"/>
                </a:xfrm>
              </p:grpSpPr>
              <p:pic>
                <p:nvPicPr>
                  <p:cNvPr id="64" name="Picture 63">
                    <a:extLst>
                      <a:ext uri="{FF2B5EF4-FFF2-40B4-BE49-F238E27FC236}">
                        <a16:creationId xmlns:a16="http://schemas.microsoft.com/office/drawing/2014/main" id="{DD8CDABC-1340-46B4-9AB3-6CD49ED5E8D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332846" y="4062668"/>
                    <a:ext cx="5961049" cy="2714999"/>
                  </a:xfrm>
                  <a:prstGeom prst="rect">
                    <a:avLst/>
                  </a:prstGeom>
                </p:spPr>
              </p:pic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9D8DA0E2-EFA5-4DA5-B914-53B30E651DA6}"/>
                      </a:ext>
                    </a:extLst>
                  </p:cNvPr>
                  <p:cNvSpPr txBox="1"/>
                  <p:nvPr/>
                </p:nvSpPr>
                <p:spPr>
                  <a:xfrm>
                    <a:off x="818301" y="4054681"/>
                    <a:ext cx="165942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AU" sz="1000" dirty="0" err="1"/>
                      <a:t>Brassinosteroid</a:t>
                    </a:r>
                    <a:r>
                      <a:rPr lang="en-AU" sz="1000" dirty="0"/>
                      <a:t> biosynthesis</a:t>
                    </a:r>
                  </a:p>
                </p:txBody>
              </p:sp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0FFE6587-D50E-420C-9A6E-1C8E54D98B34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748189" y="5208977"/>
                    <a:ext cx="109517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AU" sz="1000" dirty="0"/>
                      <a:t>GA</a:t>
                    </a:r>
                    <a:r>
                      <a:rPr lang="en-AU" sz="1000" baseline="-25000" dirty="0"/>
                      <a:t>12</a:t>
                    </a:r>
                    <a:r>
                      <a:rPr lang="en-AU" sz="1000" dirty="0"/>
                      <a:t> biosynthesis</a:t>
                    </a:r>
                  </a:p>
                </p:txBody>
              </p: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B6527908-D9EF-47E5-AF77-4FACF0E371B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275771" y="5093592"/>
                    <a:ext cx="156805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AU" sz="1000" dirty="0" err="1"/>
                      <a:t>Jasmonic</a:t>
                    </a:r>
                    <a:r>
                      <a:rPr lang="en-AU" sz="1000" dirty="0"/>
                      <a:t> acid biosynthesis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36C4692E-C782-4798-8473-330B875A09B2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626573" y="6079252"/>
                    <a:ext cx="6317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dirty="0"/>
                      <a:t>Ent-</a:t>
                    </a:r>
                    <a:r>
                      <a:rPr lang="en-AU" sz="700" dirty="0" err="1"/>
                      <a:t>kauren</a:t>
                    </a:r>
                    <a:r>
                      <a:rPr lang="en-AU" sz="700" dirty="0"/>
                      <a:t> biosynthesis</a:t>
                    </a:r>
                  </a:p>
                </p:txBody>
              </p:sp>
              <p:sp>
                <p:nvSpPr>
                  <p:cNvPr id="52" name="Rectangle 51">
                    <a:extLst>
                      <a:ext uri="{FF2B5EF4-FFF2-40B4-BE49-F238E27FC236}">
                        <a16:creationId xmlns:a16="http://schemas.microsoft.com/office/drawing/2014/main" id="{1CA5F54F-2DE1-418B-90D2-97DBB8EF0680}"/>
                      </a:ext>
                    </a:extLst>
                  </p:cNvPr>
                  <p:cNvSpPr/>
                  <p:nvPr/>
                </p:nvSpPr>
                <p:spPr>
                  <a:xfrm>
                    <a:off x="2417974" y="4172737"/>
                    <a:ext cx="1300162" cy="156405"/>
                  </a:xfrm>
                  <a:prstGeom prst="rect">
                    <a:avLst/>
                  </a:prstGeom>
                  <a:solidFill>
                    <a:srgbClr val="EFEFE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AU"/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53E79102-6B42-4053-87DF-63B2A7860968}"/>
                      </a:ext>
                    </a:extLst>
                  </p:cNvPr>
                  <p:cNvSpPr txBox="1"/>
                  <p:nvPr/>
                </p:nvSpPr>
                <p:spPr>
                  <a:xfrm>
                    <a:off x="2913878" y="4102519"/>
                    <a:ext cx="1329354" cy="15388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AU" sz="1000" dirty="0"/>
                      <a:t>Gibberellin biosynthesis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226962F6-888F-4F9A-91E2-0CD693F39834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397594" y="4483948"/>
                    <a:ext cx="1072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AU" sz="1000" dirty="0"/>
                      <a:t>ABA biosynthesis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119A39AE-39E4-4C3A-ABA6-153A5387DBE4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872327" y="6074173"/>
                    <a:ext cx="103425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AU" sz="1000" dirty="0"/>
                      <a:t>IAA biosynthesis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1C5585B2-33E8-4A1B-8CDF-29B5AD2F0874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309262" y="5898643"/>
                    <a:ext cx="890512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800" dirty="0" err="1"/>
                      <a:t>Deoxystrigol</a:t>
                    </a:r>
                    <a:r>
                      <a:rPr lang="en-AU" sz="800" dirty="0"/>
                      <a:t> biosynthesis</a:t>
                    </a:r>
                  </a:p>
                </p:txBody>
              </p:sp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C248BA06-422B-4A45-8334-C79C23EDE2B4}"/>
                      </a:ext>
                    </a:extLst>
                  </p:cNvPr>
                  <p:cNvSpPr txBox="1"/>
                  <p:nvPr/>
                </p:nvSpPr>
                <p:spPr>
                  <a:xfrm>
                    <a:off x="5003719" y="6254071"/>
                    <a:ext cx="720011" cy="24622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AU" sz="800" dirty="0" err="1"/>
                      <a:t>Jasmonoyl</a:t>
                    </a:r>
                    <a:r>
                      <a:rPr lang="en-AU" sz="800" dirty="0"/>
                      <a:t>-AA conjugates</a:t>
                    </a:r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25EF0D8C-1E73-4E12-B4C0-95A38B2B8349}"/>
                      </a:ext>
                    </a:extLst>
                  </p:cNvPr>
                  <p:cNvSpPr txBox="1"/>
                  <p:nvPr/>
                </p:nvSpPr>
                <p:spPr>
                  <a:xfrm>
                    <a:off x="5185959" y="4031359"/>
                    <a:ext cx="783458" cy="307777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AU" sz="1000" dirty="0"/>
                      <a:t>Cytokinin biosynthesis</a:t>
                    </a: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1CAE4696-DE69-4D75-B106-F8CC1AA8D95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197966" y="5164096"/>
                    <a:ext cx="912548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800" dirty="0"/>
                      <a:t>Indole-3-acetate biosynthesis</a:t>
                    </a:r>
                  </a:p>
                </p:txBody>
              </p:sp>
            </p:grpSp>
            <p:sp>
              <p:nvSpPr>
                <p:cNvPr id="66" name="Rectangle 65">
                  <a:extLst>
                    <a:ext uri="{FF2B5EF4-FFF2-40B4-BE49-F238E27FC236}">
                      <a16:creationId xmlns:a16="http://schemas.microsoft.com/office/drawing/2014/main" id="{9D851CA1-05D5-491F-85FE-A8DB7A5417F4}"/>
                    </a:ext>
                  </a:extLst>
                </p:cNvPr>
                <p:cNvSpPr/>
                <p:nvPr/>
              </p:nvSpPr>
              <p:spPr>
                <a:xfrm>
                  <a:off x="71117" y="256893"/>
                  <a:ext cx="12144947" cy="660110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/>
                </a:p>
              </p:txBody>
            </p:sp>
            <p:cxnSp>
              <p:nvCxnSpPr>
                <p:cNvPr id="68" name="Straight Connector 67">
                  <a:extLst>
                    <a:ext uri="{FF2B5EF4-FFF2-40B4-BE49-F238E27FC236}">
                      <a16:creationId xmlns:a16="http://schemas.microsoft.com/office/drawing/2014/main" id="{9B3DE65F-1512-4913-8D4F-65C9A03295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1117" y="4086833"/>
                  <a:ext cx="1214494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Straight Connector 69">
                  <a:extLst>
                    <a:ext uri="{FF2B5EF4-FFF2-40B4-BE49-F238E27FC236}">
                      <a16:creationId xmlns:a16="http://schemas.microsoft.com/office/drawing/2014/main" id="{2EE8A191-E794-41CF-A8D0-CA44E3588F37}"/>
                    </a:ext>
                  </a:extLst>
                </p:cNvPr>
                <p:cNvCxnSpPr/>
                <p:nvPr/>
              </p:nvCxnSpPr>
              <p:spPr>
                <a:xfrm>
                  <a:off x="6329442" y="4086833"/>
                  <a:ext cx="0" cy="277116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Straight Connector 70">
                  <a:extLst>
                    <a:ext uri="{FF2B5EF4-FFF2-40B4-BE49-F238E27FC236}">
                      <a16:creationId xmlns:a16="http://schemas.microsoft.com/office/drawing/2014/main" id="{6B33D24D-C26D-44D3-8CBB-EC09AAB80915}"/>
                    </a:ext>
                  </a:extLst>
                </p:cNvPr>
                <p:cNvCxnSpPr/>
                <p:nvPr/>
              </p:nvCxnSpPr>
              <p:spPr>
                <a:xfrm>
                  <a:off x="10892096" y="4094894"/>
                  <a:ext cx="0" cy="277116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3" name="Rectangle: Rounded Corners 72">
                <a:extLst>
                  <a:ext uri="{FF2B5EF4-FFF2-40B4-BE49-F238E27FC236}">
                    <a16:creationId xmlns:a16="http://schemas.microsoft.com/office/drawing/2014/main" id="{CDBC3ED5-3A58-4405-8746-72734958E47B}"/>
                  </a:ext>
                </a:extLst>
              </p:cNvPr>
              <p:cNvSpPr/>
              <p:nvPr/>
            </p:nvSpPr>
            <p:spPr>
              <a:xfrm>
                <a:off x="409209" y="2606950"/>
                <a:ext cx="1888825" cy="822049"/>
              </a:xfrm>
              <a:prstGeom prst="roundRect">
                <a:avLst/>
              </a:prstGeom>
              <a:noFill/>
              <a:ln w="19050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40479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83</TotalTime>
  <Words>516</Words>
  <Application>Microsoft Office PowerPoint</Application>
  <PresentationFormat>Widescreen</PresentationFormat>
  <Paragraphs>6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Arial Black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phine E Vincent (DJPR)</dc:creator>
  <cp:lastModifiedBy>Delphine E Vincent (DJPR)</cp:lastModifiedBy>
  <cp:revision>423</cp:revision>
  <dcterms:created xsi:type="dcterms:W3CDTF">2021-08-30T04:44:27Z</dcterms:created>
  <dcterms:modified xsi:type="dcterms:W3CDTF">2021-12-22T05:50:37Z</dcterms:modified>
</cp:coreProperties>
</file>